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312" y="-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54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120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374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787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9046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8622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8960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1128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403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859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22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DB431-F0AF-4667-A923-91DE3B1544BE}" type="datetimeFigureOut">
              <a:rPr lang="en-GB" smtClean="0"/>
              <a:t>15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3663B-2643-4893-B16E-21C1C8D4D2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812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202918" y="121777"/>
            <a:ext cx="6750349" cy="3065027"/>
            <a:chOff x="1259632" y="940036"/>
            <a:chExt cx="6750349" cy="306502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6" t="2577" r="1739" b="33546"/>
            <a:stretch/>
          </p:blipFill>
          <p:spPr bwMode="auto">
            <a:xfrm>
              <a:off x="1259632" y="940036"/>
              <a:ext cx="6750349" cy="3065027"/>
            </a:xfrm>
            <a:prstGeom prst="rect">
              <a:avLst/>
            </a:prstGeom>
            <a:noFill/>
            <a:ln w="31750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7" name="Group 6"/>
            <p:cNvGrpSpPr/>
            <p:nvPr/>
          </p:nvGrpSpPr>
          <p:grpSpPr>
            <a:xfrm>
              <a:off x="2851382" y="2060848"/>
              <a:ext cx="5104994" cy="672972"/>
              <a:chOff x="2851382" y="2060848"/>
              <a:chExt cx="5104994" cy="67297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2851382" y="2333679"/>
                <a:ext cx="114455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/>
                  <a:t>Conjugate control</a:t>
                </a:r>
                <a:endParaRPr lang="en-GB" sz="10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4067944" y="2487599"/>
                <a:ext cx="12961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/>
                  <a:t>Complement control</a:t>
                </a:r>
                <a:endParaRPr lang="en-GB" sz="10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6948264" y="2060848"/>
                <a:ext cx="1008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/>
                  <a:t>Test serum</a:t>
                </a:r>
                <a:endParaRPr lang="en-GB" sz="1000" dirty="0"/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1202917" y="3279837"/>
            <a:ext cx="6750350" cy="3063600"/>
            <a:chOff x="1202917" y="3279837"/>
            <a:chExt cx="6750350" cy="3063600"/>
          </a:xfrm>
        </p:grpSpPr>
        <p:pic>
          <p:nvPicPr>
            <p:cNvPr id="1027" name="Picture 3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6" t="2185" r="1385" b="31388"/>
            <a:stretch/>
          </p:blipFill>
          <p:spPr bwMode="auto">
            <a:xfrm>
              <a:off x="1202917" y="3279837"/>
              <a:ext cx="6750350" cy="3063600"/>
            </a:xfrm>
            <a:prstGeom prst="rect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2866677" y="4688526"/>
              <a:ext cx="11445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Conjugate control</a:t>
              </a:r>
              <a:endParaRPr lang="en-GB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63630" y="4688526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Complement control</a:t>
              </a:r>
              <a:endParaRPr lang="en-GB" sz="1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891550" y="4442305"/>
              <a:ext cx="1008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Test serum</a:t>
              </a:r>
              <a:endParaRPr lang="en-GB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67430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12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 Allen</dc:creator>
  <cp:lastModifiedBy>Kirsty  Le Doare</cp:lastModifiedBy>
  <cp:revision>3</cp:revision>
  <dcterms:created xsi:type="dcterms:W3CDTF">2014-11-10T15:04:07Z</dcterms:created>
  <dcterms:modified xsi:type="dcterms:W3CDTF">2014-11-15T09:32:01Z</dcterms:modified>
</cp:coreProperties>
</file>